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660" autoAdjust="0"/>
  </p:normalViewPr>
  <p:slideViewPr>
    <p:cSldViewPr>
      <p:cViewPr varScale="1">
        <p:scale>
          <a:sx n="80" d="100"/>
          <a:sy n="80" d="100"/>
        </p:scale>
        <p:origin x="170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9FF215-F889-4FF2-B67D-B92A4DEF83CA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09DF6-8814-4531-A0CF-E3BF5DE3C1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34782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(a) </a:t>
            </a:r>
            <a:r>
              <a:rPr lang="en-US" altLang="zh-CN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tal ions current of  one quality control  sample by mass spectrometry; (b) Multi-peak detection plot of metabolites in the multiple reaction monitoring mode; (c</a:t>
            </a:r>
            <a:r>
              <a:rPr lang="en-US" altLang="zh-CN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Total ions current overlaps of the quality control samples by mass spectrometry detection.</a:t>
            </a:r>
            <a:endParaRPr lang="zh-CN" altLang="en-US" b="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1B3B9-2FA0-49E7-A450-A25E5CCED02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49230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</a:t>
            </a:r>
            <a:r>
              <a:rPr lang="en-US" altLang="zh-CN" dirty="0" smtClean="0"/>
              <a:t>Principal component analysis score diagram for mass spectrum data of samples and quality control samples. The X-axis represents the first principal component (PC1), and the Y-axis represents the second principal component (PC2)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09DF6-8814-4531-A0CF-E3BF5DE3C1B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58320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 (a) Score scatter plot of the orthogonal projections to latent structures-discriminant analysis (OPLS-DA)  model;</a:t>
            </a:r>
            <a:r>
              <a:rPr lang="en-US" altLang="zh-CN" b="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altLang="zh-CN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ermutation test of the OPLS-DA model.</a:t>
            </a:r>
            <a:endParaRPr lang="zh-CN" altLang="en-US" b="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09DF6-8814-4531-A0CF-E3BF5DE3C1B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3625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 Content of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2 metabolites with different contents in the three periods of leaf color change.</a:t>
            </a:r>
            <a:endParaRPr lang="zh-CN" altLang="en-US" b="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09DF6-8814-4531-A0CF-E3BF5DE3C1BC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443170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Enzyme active of </a:t>
            </a:r>
            <a:r>
              <a:rPr lang="en-US" altLang="zh-CN" b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hocyanidin</a:t>
            </a: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-O-glucosyltransferase (UFGT) and gene expression of </a:t>
            </a:r>
            <a:r>
              <a:rPr lang="en-US" altLang="zh-CN" b="0" i="1" u="non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FGT</a:t>
            </a: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uring</a:t>
            </a:r>
            <a:r>
              <a:rPr lang="en-US" altLang="zh-CN" b="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US" altLang="zh-CN" dirty="0" smtClean="0"/>
              <a:t>period of leaf color change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09DF6-8814-4531-A0CF-E3BF5DE3C1BC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88406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b="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</a:t>
            </a:r>
            <a:r>
              <a:rPr lang="en-US" altLang="zh-CN" b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onfiguration route of working </a:t>
            </a:r>
            <a:r>
              <a:rPr lang="en-US" altLang="zh-CN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lution for the determination of total flavonoids</a:t>
            </a:r>
            <a:r>
              <a:rPr lang="en-US" altLang="zh-CN" sz="120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09DF6-8814-4531-A0CF-E3BF5DE3C1BC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8462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-3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9588" y="260648"/>
            <a:ext cx="3600400" cy="19086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矩形 3"/>
          <p:cNvSpPr/>
          <p:nvPr/>
        </p:nvSpPr>
        <p:spPr>
          <a:xfrm>
            <a:off x="6424765" y="8241"/>
            <a:ext cx="123463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C_MS_TIC-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1156" y="268434"/>
            <a:ext cx="3600000" cy="19008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矩形 6"/>
          <p:cNvSpPr/>
          <p:nvPr/>
        </p:nvSpPr>
        <p:spPr>
          <a:xfrm>
            <a:off x="2583839" y="40213"/>
            <a:ext cx="12186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C_MS_TIC-P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3140" y="2625879"/>
            <a:ext cx="3600000" cy="19104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矩形 4"/>
          <p:cNvSpPr/>
          <p:nvPr/>
        </p:nvSpPr>
        <p:spPr>
          <a:xfrm>
            <a:off x="1761499" y="2384505"/>
            <a:ext cx="28793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M_detection_of_multimodal_map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9988" y="2633445"/>
            <a:ext cx="3600000" cy="19028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矩形 10"/>
          <p:cNvSpPr/>
          <p:nvPr/>
        </p:nvSpPr>
        <p:spPr>
          <a:xfrm>
            <a:off x="5650331" y="2394180"/>
            <a:ext cx="28793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M_detection_of_multimodal_maps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2425" y="4913436"/>
            <a:ext cx="3600000" cy="18999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矩形 5"/>
          <p:cNvSpPr/>
          <p:nvPr/>
        </p:nvSpPr>
        <p:spPr>
          <a:xfrm>
            <a:off x="2340688" y="4672062"/>
            <a:ext cx="16834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C_MS_tic_overlap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3442" y="4898851"/>
            <a:ext cx="3597275" cy="191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矩形 18"/>
          <p:cNvSpPr/>
          <p:nvPr/>
        </p:nvSpPr>
        <p:spPr>
          <a:xfrm>
            <a:off x="6200343" y="4636436"/>
            <a:ext cx="16834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C_MS_tic_overlap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1257141" y="40213"/>
            <a:ext cx="7848872" cy="225820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1259632" y="2394180"/>
            <a:ext cx="7848872" cy="22066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1257141" y="4672062"/>
            <a:ext cx="7848872" cy="214131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899592" y="46305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99905" y="239418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00218" y="467815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0" y="-37926"/>
            <a:ext cx="11851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79986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1668" y="548680"/>
            <a:ext cx="5715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-37926"/>
            <a:ext cx="2699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932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937" y="621008"/>
            <a:ext cx="2880000" cy="28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4452" y="621008"/>
            <a:ext cx="2880000" cy="28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504" y="621008"/>
            <a:ext cx="2880000" cy="28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937" y="3844398"/>
            <a:ext cx="2880000" cy="28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4080" y="3844398"/>
            <a:ext cx="2880000" cy="28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504" y="3844398"/>
            <a:ext cx="2880000" cy="28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矩形 7"/>
          <p:cNvSpPr/>
          <p:nvPr/>
        </p:nvSpPr>
        <p:spPr>
          <a:xfrm>
            <a:off x="350936" y="404664"/>
            <a:ext cx="8757567" cy="309634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350935" y="3645024"/>
            <a:ext cx="8757567" cy="309634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TextBox 9"/>
          <p:cNvSpPr txBox="1"/>
          <p:nvPr/>
        </p:nvSpPr>
        <p:spPr>
          <a:xfrm>
            <a:off x="0" y="415637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27620" y="386136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0" y="-37926"/>
            <a:ext cx="2699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176320" y="404664"/>
            <a:ext cx="14141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L_vs_GL_opls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4106995" y="418564"/>
            <a:ext cx="14141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_vs_YL_opls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6961419" y="404664"/>
            <a:ext cx="14141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L_vs_GL_oplsd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727479" y="3705898"/>
            <a:ext cx="23118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L_vs_GL_oplsda_permutat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658154" y="3722868"/>
            <a:ext cx="230223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_vs_YL_oplsda_permutat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6517387" y="3722867"/>
            <a:ext cx="23118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L_vs_GL_oplsda_permutat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98359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11"/>
          <p:cNvSpPr txBox="1"/>
          <p:nvPr/>
        </p:nvSpPr>
        <p:spPr>
          <a:xfrm>
            <a:off x="0" y="-37926"/>
            <a:ext cx="2699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528" y="1628800"/>
            <a:ext cx="8545680" cy="2829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1054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9999" y="1484784"/>
            <a:ext cx="4499999" cy="270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484784"/>
            <a:ext cx="4499999" cy="2700000"/>
          </a:xfrm>
          <a:prstGeom prst="rect">
            <a:avLst/>
          </a:prstGeom>
        </p:spPr>
      </p:pic>
      <p:sp>
        <p:nvSpPr>
          <p:cNvPr id="5" name="TextBox 11"/>
          <p:cNvSpPr txBox="1"/>
          <p:nvPr/>
        </p:nvSpPr>
        <p:spPr>
          <a:xfrm>
            <a:off x="0" y="-37926"/>
            <a:ext cx="2699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11899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134" y="2207880"/>
            <a:ext cx="7829731" cy="2442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5331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9</TotalTime>
  <Words>223</Words>
  <Application>Microsoft Office PowerPoint</Application>
  <PresentationFormat>全屏显示(4:3)</PresentationFormat>
  <Paragraphs>34</Paragraphs>
  <Slides>6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e</dc:creator>
  <cp:lastModifiedBy>lenovo</cp:lastModifiedBy>
  <cp:revision>23</cp:revision>
  <dcterms:created xsi:type="dcterms:W3CDTF">2019-12-10T07:16:45Z</dcterms:created>
  <dcterms:modified xsi:type="dcterms:W3CDTF">2020-03-05T04:07:26Z</dcterms:modified>
</cp:coreProperties>
</file>